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4.bin" ContentType="application/vnd.openxmlformats-officedocument.oleObject"/>
  <Override PartName="/ppt/embeddings/oleObject2.xlsx" ContentType="application/vnd.openxmlformats-officedocument.spreadsheetml.sheet"/>
  <Override PartName="/ppt/embeddings/oleObject3.bin" ContentType="application/vnd.openxmlformats-officedocument.oleObject"/>
  <Override PartName="/ppt/embeddings/oleObject5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A2C1F-EF81-4333-85E4-C939EDDBE7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87558-36FA-4EBA-9367-12A95C9683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3DDD4-4A68-4AC6-BE9A-931508B0D5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4DCC0-59EA-4EDC-A979-F630D341F9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4EBF7B-2BCD-4B66-88F7-003E0511D9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F4476-42A8-4ACA-8B1B-183B3E7050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878C9-A337-4DCB-9192-73470AF31F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A45BB-E877-4036-8DF1-D3AEBB9065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62F08-51D3-47AB-8033-750AF68E3A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79AC5-E601-46AE-A3A7-F0C64E02CD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AAEC8-59F6-473F-8826-F09F6A72B3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AFEB97-D95F-4249-9FBA-79F0F02BC2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78255C-69E1-4BD8-B145-03A90A58D95A}" type="slidenum">
              <a:rPr b="0" lang="sv-S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400680" y="555840"/>
            <a:ext cx="81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 rot="16200000">
            <a:off x="976320" y="6739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C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1366920" y="63900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S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163600" y="1546200"/>
            <a:ext cx="82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GSK3</a:t>
            </a: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151000" y="1162080"/>
            <a:ext cx="115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GSK3</a:t>
            </a: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er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163600" y="1825560"/>
            <a:ext cx="82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"/>
          <p:cNvGrpSpPr/>
          <p:nvPr/>
        </p:nvGrpSpPr>
        <p:grpSpPr>
          <a:xfrm>
            <a:off x="2867040" y="3216240"/>
            <a:ext cx="3990960" cy="2722320"/>
            <a:chOff x="2867040" y="3216240"/>
            <a:chExt cx="3990960" cy="2722320"/>
          </a:xfrm>
        </p:grpSpPr>
        <p:graphicFrame>
          <p:nvGraphicFramePr>
            <p:cNvPr id="48" name=""/>
            <p:cNvGraphicFramePr/>
            <p:nvPr/>
          </p:nvGraphicFramePr>
          <p:xfrm>
            <a:off x="3375000" y="3303720"/>
            <a:ext cx="3436920" cy="22622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9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375000" y="3303720"/>
                      <a:ext cx="3436920" cy="2262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0" name=""/>
            <p:cNvSpPr/>
            <p:nvPr/>
          </p:nvSpPr>
          <p:spPr>
            <a:xfrm>
              <a:off x="3317760" y="5613480"/>
              <a:ext cx="71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006800" y="5613480"/>
              <a:ext cx="44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TS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519440" y="5613480"/>
              <a:ext cx="58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SB 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047920" y="5613480"/>
              <a:ext cx="622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SB 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553000" y="5613480"/>
              <a:ext cx="681120" cy="325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SB 5 +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TS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162480" y="5613480"/>
              <a:ext cx="695520" cy="325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SB 10 +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TS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"/>
            <p:cNvGrpSpPr/>
            <p:nvPr/>
          </p:nvGrpSpPr>
          <p:grpSpPr>
            <a:xfrm>
              <a:off x="3011400" y="3216240"/>
              <a:ext cx="398520" cy="2451240"/>
              <a:chOff x="3011400" y="3216240"/>
              <a:chExt cx="398520" cy="2451240"/>
            </a:xfrm>
          </p:grpSpPr>
          <p:sp>
            <p:nvSpPr>
              <p:cNvPr id="57" name=""/>
              <p:cNvSpPr/>
              <p:nvPr/>
            </p:nvSpPr>
            <p:spPr>
              <a:xfrm>
                <a:off x="3057120" y="3945960"/>
                <a:ext cx="352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029040" y="4297680"/>
                <a:ext cx="380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044880" y="4657680"/>
                <a:ext cx="364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011400" y="3579840"/>
                <a:ext cx="39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011400" y="3216240"/>
                <a:ext cx="398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3072960" y="5068440"/>
                <a:ext cx="336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133800" y="5421240"/>
                <a:ext cx="275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4" name=""/>
            <p:cNvSpPr/>
            <p:nvPr/>
          </p:nvSpPr>
          <p:spPr>
            <a:xfrm rot="16200000">
              <a:off x="2040840" y="4296600"/>
              <a:ext cx="1898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Cell survival (Percent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682960" y="4927680"/>
              <a:ext cx="257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157800" y="4849920"/>
              <a:ext cx="371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sv-SE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"/>
          <p:cNvGrpSpPr/>
          <p:nvPr/>
        </p:nvGrpSpPr>
        <p:grpSpPr>
          <a:xfrm>
            <a:off x="65160" y="6515280"/>
            <a:ext cx="3868560" cy="2630520"/>
            <a:chOff x="65160" y="6515280"/>
            <a:chExt cx="3868560" cy="2630520"/>
          </a:xfrm>
        </p:grpSpPr>
        <p:graphicFrame>
          <p:nvGraphicFramePr>
            <p:cNvPr id="68" name=""/>
            <p:cNvGraphicFramePr/>
            <p:nvPr/>
          </p:nvGraphicFramePr>
          <p:xfrm>
            <a:off x="533520" y="6629400"/>
            <a:ext cx="3400200" cy="215280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69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33520" y="6629400"/>
                      <a:ext cx="3400200" cy="2152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70" name=""/>
            <p:cNvGrpSpPr/>
            <p:nvPr/>
          </p:nvGrpSpPr>
          <p:grpSpPr>
            <a:xfrm>
              <a:off x="219240" y="6515280"/>
              <a:ext cx="398160" cy="2451240"/>
              <a:chOff x="219240" y="6515280"/>
              <a:chExt cx="398160" cy="2451240"/>
            </a:xfrm>
          </p:grpSpPr>
          <p:sp>
            <p:nvSpPr>
              <p:cNvPr id="71" name=""/>
              <p:cNvSpPr/>
              <p:nvPr/>
            </p:nvSpPr>
            <p:spPr>
              <a:xfrm>
                <a:off x="264960" y="7245000"/>
                <a:ext cx="352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36880" y="7596720"/>
                <a:ext cx="380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52720" y="7956720"/>
                <a:ext cx="364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19240" y="6878880"/>
                <a:ext cx="398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19240" y="6515280"/>
                <a:ext cx="398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80800" y="8367480"/>
                <a:ext cx="336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341280" y="8720280"/>
                <a:ext cx="275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sv-SE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"/>
            <p:cNvSpPr/>
            <p:nvPr/>
          </p:nvSpPr>
          <p:spPr>
            <a:xfrm rot="16200000">
              <a:off x="-760680" y="7443000"/>
              <a:ext cx="1898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Cell survival (Percent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647720" y="7847280"/>
              <a:ext cx="371520" cy="314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370320" y="7607520"/>
              <a:ext cx="371520" cy="314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375000" y="7605720"/>
              <a:ext cx="371520" cy="337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658800" y="8747280"/>
              <a:ext cx="71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619280" y="8747280"/>
              <a:ext cx="439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TS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465280" y="8747280"/>
              <a:ext cx="46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LiC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263760" y="8747280"/>
              <a:ext cx="5637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sv-SE" sz="1000" spc="-1" strike="noStrike">
                  <a:solidFill>
                    <a:srgbClr val="000000"/>
                  </a:solidFill>
                  <a:latin typeface="Arial"/>
                </a:rPr>
                <a:t>TSA + LiC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"/>
          <p:cNvSpPr/>
          <p:nvPr/>
        </p:nvSpPr>
        <p:spPr>
          <a:xfrm>
            <a:off x="260280" y="243000"/>
            <a:ext cx="35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867040" y="2855880"/>
            <a:ext cx="35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747960" y="257040"/>
            <a:ext cx="35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0" y="6084720"/>
            <a:ext cx="35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Arial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0" name=""/>
          <p:cNvGraphicFramePr/>
          <p:nvPr/>
        </p:nvGraphicFramePr>
        <p:xfrm>
          <a:off x="593640" y="1101600"/>
          <a:ext cx="1374840" cy="968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91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93640" y="1101600"/>
                    <a:ext cx="1374840" cy="968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2" name=""/>
          <p:cNvSpPr/>
          <p:nvPr/>
        </p:nvSpPr>
        <p:spPr>
          <a:xfrm>
            <a:off x="5691240" y="1790640"/>
            <a:ext cx="116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GSK3</a:t>
            </a: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er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691240" y="2076480"/>
            <a:ext cx="799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GSK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16200000">
            <a:off x="3883320" y="661320"/>
            <a:ext cx="77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rot="16200000">
            <a:off x="4715640" y="581760"/>
            <a:ext cx="92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A 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16200000">
            <a:off x="4280040" y="75060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rot="16200000">
            <a:off x="4544280" y="716760"/>
            <a:ext cx="65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OA 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691240" y="2414520"/>
            <a:ext cx="63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691240" y="1442880"/>
            <a:ext cx="54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k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691240" y="1201680"/>
            <a:ext cx="1019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pAktSer4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1" name=""/>
          <p:cNvGraphicFramePr/>
          <p:nvPr/>
        </p:nvGraphicFramePr>
        <p:xfrm>
          <a:off x="4132440" y="1160640"/>
          <a:ext cx="1244520" cy="14824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2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132440" y="1160640"/>
                    <a:ext cx="1244520" cy="1482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103" name=""/>
          <p:cNvGrpSpPr/>
          <p:nvPr/>
        </p:nvGrpSpPr>
        <p:grpSpPr>
          <a:xfrm>
            <a:off x="260280" y="3161880"/>
            <a:ext cx="2600280" cy="2512080"/>
            <a:chOff x="260280" y="3161880"/>
            <a:chExt cx="2600280" cy="2512080"/>
          </a:xfrm>
        </p:grpSpPr>
        <p:sp>
          <p:nvSpPr>
            <p:cNvPr id="104" name=""/>
            <p:cNvSpPr/>
            <p:nvPr/>
          </p:nvSpPr>
          <p:spPr>
            <a:xfrm rot="16200000">
              <a:off x="96840" y="3488760"/>
              <a:ext cx="774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16200000">
              <a:off x="1037880" y="3442680"/>
              <a:ext cx="838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SA+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16200000">
              <a:off x="600120" y="3544920"/>
              <a:ext cx="74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S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612800" y="4559400"/>
              <a:ext cx="546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k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612800" y="4086360"/>
              <a:ext cx="10191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ktSer47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612800" y="5050080"/>
              <a:ext cx="1247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GSK3</a:t>
              </a:r>
              <a:r>
                <a:rPr b="1" lang="el-G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r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627200" y="5397480"/>
              <a:ext cx="799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SK3</a:t>
              </a:r>
              <a:r>
                <a:rPr b="1" lang="el-G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11" name=""/>
            <p:cNvGraphicFramePr/>
            <p:nvPr/>
          </p:nvGraphicFramePr>
          <p:xfrm>
            <a:off x="260280" y="4010040"/>
            <a:ext cx="1371600" cy="163044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112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260280" y="4010040"/>
                      <a:ext cx="1371600" cy="1630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113" name=""/>
          <p:cNvSpPr/>
          <p:nvPr/>
        </p:nvSpPr>
        <p:spPr>
          <a:xfrm>
            <a:off x="0" y="2855880"/>
            <a:ext cx="35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2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994040" y="1308240"/>
            <a:ext cx="1904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994040" y="1701720"/>
            <a:ext cx="1904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5410080" y="1892160"/>
            <a:ext cx="19080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5410080" y="2222640"/>
            <a:ext cx="19080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04T15:03:32Z</dcterms:created>
  <dc:creator>John Patrick</dc:creator>
  <dc:description/>
  <dc:language>en-US</dc:language>
  <cp:lastModifiedBy>John Patrick</cp:lastModifiedBy>
  <dcterms:modified xsi:type="dcterms:W3CDTF">2006-09-09T20:20:13Z</dcterms:modified>
  <cp:revision>3</cp:revision>
  <dc:subject/>
  <dc:title>Slide 1</dc:title>
</cp:coreProperties>
</file>